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136" d="100"/>
          <a:sy n="136" d="100"/>
        </p:scale>
        <p:origin x="-1992" y="-10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0DB3EA-0AB7-47F3-B182-D26F95E24A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E5A43B5-B65F-4AB7-8A7F-D2984518D4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320FF90-8CBA-46A1-B29A-8CC69AD4B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E09F044-1F25-4579-B7C0-C47431BBA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2C4CEC-15AA-45A2-A5D8-5562AC230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93589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06F83C-FB7B-48BD-A5F2-68FC4A2A0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891D018-AE8D-4405-BABC-55DA8B0727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808F02B-C88E-4412-B826-639B2A45B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F83EBB9-6500-4414-A217-109055762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ADE189C-5321-4A5C-957E-FA83172A6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03404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DD3AB69-FB7E-4800-9A42-0FF858338F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C28D810-4A70-43E6-BD51-F01811B396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EC1008-D13C-4ACC-9C35-4B73DDBFD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9EC60FF-58DF-4D09-9DF9-37B3F5DF4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A9020A8-C017-45BB-9C52-BC76ABA7D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888390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78951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30B1C1-6EB8-49B6-BBB7-D48037E7EE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F3B8325-ECC5-4EE1-9E57-5C40E10089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BF0587-99D7-48D7-8AED-732AE542E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946DEAE-D94B-4F3F-A933-CA8C595A9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3CBCDB0-2346-4BD9-8F1D-F76607174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61423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4B5609-88E4-4AD7-BBB5-27855C1F0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3CC8CCC-F471-4C96-A72A-214D1B0A09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7ECAFD-9DDE-46E0-93D1-338FA87FC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E67087-0689-4B2C-835D-29BDBAF5C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AA6D72-076F-48DC-B4F2-4142AEA86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61224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9FEF40-CD8D-4584-B7BA-79CEE6915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83645D9-54A0-4719-88B5-2EDFBDB3DA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75F378E-AB61-4DDF-A177-D7B1AC5FDC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E993CDD-B390-4562-9832-C3CBFE10B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19346F4-2147-4189-992A-3AB1B03FF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2D339C9-E0CC-4AE6-9A33-4BBCACE64A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19025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8BC535-A058-4985-B29D-5CEA156349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D5A437E-924E-4D57-80C8-DB64AF9BDB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8DC19E9-C4F1-4DEE-A9E0-280C6E7C9A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1A541CC-3519-449A-9AAC-6D2989FBAE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2ABB5CB-8510-4F29-97C5-3E9DFB20C4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FB4FBA5-A2BF-4412-83D0-AE4A2D0E2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D07E5C9-8241-4960-A11E-3E0B88D65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FE77DA9-E40E-466D-8FD5-F961A1DB1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8010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BA964C4-92EA-4C0D-B36A-C54253C82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A6AFBFB-8866-4004-8EE0-C2A9BE7BD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CD7E5BB-EA18-4B91-B5D4-7A7CFD5FB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BC39F2D-D382-4F9E-B907-954A9C13E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76584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DE39B2F-69D0-439F-9025-225DEA918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F345D6A-FCD7-4951-94DB-D840370CD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C95C1B9-9D9F-446F-A334-C8C61EC36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35204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B1CED7-7D5D-4ADE-A345-09BA75CA0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B1BF84-B41B-4365-A322-076ABC6B72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B13C44A-840C-48AB-95BC-F5C0806FBC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9C9B0DA-53C0-44E4-96C3-14DCB574E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AFDCFAA-2141-47E6-B8E8-DECF674D8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0951455-69BA-4C5B-B415-6653BCFC6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0021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EBBABC-F5C4-4A79-A0E7-98E9669FD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23AFEFC-8B66-4127-98CC-9618D68633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CC6597B-4A4E-404C-94FA-4FD51D6B4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6775B34-9F4C-4F01-859D-9711AB583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F31725D-9786-447C-B932-E7F11F4E9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2616282-7D76-4AC9-8B8B-E7427C144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05991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FDBE789-CBEC-427D-AE57-B1E4FAB27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706F4A4-8EC5-4B49-AB60-98EAA87F02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8197C67-7040-4BB7-886A-B7FC08D48B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AC9D7-4817-4196-85FE-7BD9D426BC3A}" type="datetimeFigureOut">
              <a:rPr lang="de-CH" smtClean="0"/>
              <a:t>24.01.20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DD46E3-3F0A-48A7-8B4E-4A2EFCCF90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92190E8-356A-4EB2-B341-0659FDE8D1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263D7-561D-4BB2-AD25-50BC26F49151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83913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g"/><Relationship Id="rId3" Type="http://schemas.microsoft.com/office/2007/relationships/hdphoto" Target="../media/hdphoto1.wdp"/><Relationship Id="rId7" Type="http://schemas.openxmlformats.org/officeDocument/2006/relationships/image" Target="../media/image5.jpeg"/><Relationship Id="rId12" Type="http://schemas.openxmlformats.org/officeDocument/2006/relationships/image" Target="../media/image10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11" Type="http://schemas.openxmlformats.org/officeDocument/2006/relationships/image" Target="../media/image9.jp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Grafik 62">
            <a:extLst>
              <a:ext uri="{FF2B5EF4-FFF2-40B4-BE49-F238E27FC236}">
                <a16:creationId xmlns:a16="http://schemas.microsoft.com/office/drawing/2014/main" id="{EE0F7C0E-8091-4C15-B49C-0079741848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0" b="100000" l="0" r="100000">
                        <a14:foregroundMark x1="5201" y1="24533" x2="42785" y2="23014"/>
                        <a14:foregroundMark x1="39430" y1="24299" x2="34060" y2="26168"/>
                        <a14:foregroundMark x1="17617" y1="66355" x2="20470" y2="97196"/>
                        <a14:foregroundMark x1="11409" y1="87967" x2="4530" y2="69743"/>
                        <a14:foregroundMark x1="4362" y1="69393" x2="3020" y2="59112"/>
                        <a14:foregroundMark x1="2852" y1="57593" x2="3188" y2="24065"/>
                        <a14:foregroundMark x1="39765" y1="61916" x2="39933" y2="23598"/>
                        <a14:foregroundMark x1="34564" y1="24650" x2="14597" y2="24766"/>
                        <a14:foregroundMark x1="35738" y1="71963" x2="38087" y2="69626"/>
                        <a14:foregroundMark x1="38591" y1="68575" x2="39933" y2="61565"/>
                        <a14:foregroundMark x1="38087" y1="70911" x2="31711" y2="87383"/>
                        <a14:foregroundMark x1="31711" y1="88551" x2="25671" y2="98364"/>
                        <a14:foregroundMark x1="17953" y1="98481" x2="11409" y2="89136"/>
                        <a14:foregroundMark x1="11074" y1="89136" x2="11074" y2="89136"/>
                        <a14:foregroundMark x1="11409" y1="89836" x2="11409" y2="89836"/>
                        <a14:foregroundMark x1="671" y1="24533" x2="671" y2="21846"/>
                        <a14:foregroundMark x1="839" y1="21846" x2="42114" y2="21846"/>
                        <a14:foregroundMark x1="42953" y1="22664" x2="63087" y2="21612"/>
                        <a14:foregroundMark x1="44631" y1="24065" x2="59060" y2="22430"/>
                        <a14:foregroundMark x1="50336" y1="24065" x2="54362" y2="23715"/>
                        <a14:foregroundMark x1="61409" y1="19042" x2="96644" y2="5491"/>
                        <a14:foregroundMark x1="96980" y1="5374" x2="98826" y2="7243"/>
                        <a14:foregroundMark x1="98993" y1="7477" x2="62416" y2="21612"/>
                        <a14:foregroundMark x1="63423" y1="17523" x2="56879" y2="11332"/>
                        <a14:foregroundMark x1="56879" y1="11332" x2="85738" y2="234"/>
                        <a14:foregroundMark x1="85738" y1="234" x2="92617" y2="6659"/>
                        <a14:foregroundMark x1="81208" y1="9346" x2="76846" y2="9463"/>
                        <a14:foregroundMark x1="64933" y1="12967" x2="88423" y2="5607"/>
                        <a14:foregroundMark x1="20470" y1="99416" x2="22315" y2="99416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929357" y="3576480"/>
            <a:ext cx="1603192" cy="2302570"/>
          </a:xfrm>
          <a:prstGeom prst="rect">
            <a:avLst/>
          </a:prstGeom>
        </p:spPr>
      </p:pic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2FE5545B-8B36-4E06-B685-E82E5CD9AA99}"/>
              </a:ext>
            </a:extLst>
          </p:cNvPr>
          <p:cNvCxnSpPr/>
          <p:nvPr/>
        </p:nvCxnSpPr>
        <p:spPr bwMode="auto">
          <a:xfrm rot="2100000">
            <a:off x="2169492" y="2470719"/>
            <a:ext cx="1041365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4" name="Textfeld 83">
            <a:extLst>
              <a:ext uri="{FF2B5EF4-FFF2-40B4-BE49-F238E27FC236}">
                <a16:creationId xmlns:a16="http://schemas.microsoft.com/office/drawing/2014/main" id="{C25EA211-2420-456E-BDC2-D78734281DEF}"/>
              </a:ext>
            </a:extLst>
          </p:cNvPr>
          <p:cNvSpPr txBox="1"/>
          <p:nvPr/>
        </p:nvSpPr>
        <p:spPr>
          <a:xfrm>
            <a:off x="7460008" y="2875226"/>
            <a:ext cx="1126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Proteins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8346B3AC-62BE-4657-A3B1-453F145B61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7977" y="635254"/>
            <a:ext cx="1001070" cy="1541166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945B1073-7826-4555-B87C-0828C1E758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4235" y="4649561"/>
            <a:ext cx="1517638" cy="1517638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C84F347A-86AC-43A3-ABC7-25803F8636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6257" y="2835920"/>
            <a:ext cx="1534218" cy="1217369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BE6A80F3-3499-4836-81BF-30E2FCA49BCF}"/>
              </a:ext>
            </a:extLst>
          </p:cNvPr>
          <p:cNvSpPr txBox="1"/>
          <p:nvPr/>
        </p:nvSpPr>
        <p:spPr>
          <a:xfrm>
            <a:off x="591200" y="103539"/>
            <a:ext cx="14087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err="1"/>
              <a:t>Novel</a:t>
            </a:r>
            <a:r>
              <a:rPr lang="de-CH" sz="2000" b="1" dirty="0"/>
              <a:t> </a:t>
            </a:r>
            <a:r>
              <a:rPr lang="de-CH" sz="2000" b="1" dirty="0" err="1"/>
              <a:t>food</a:t>
            </a:r>
            <a:r>
              <a:rPr lang="de-CH" sz="2000" b="1" dirty="0"/>
              <a:t> 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C58ADE39-DF2F-447B-A177-746EF6424ACD}"/>
              </a:ext>
            </a:extLst>
          </p:cNvPr>
          <p:cNvSpPr txBox="1"/>
          <p:nvPr/>
        </p:nvSpPr>
        <p:spPr>
          <a:xfrm>
            <a:off x="5203652" y="3237895"/>
            <a:ext cx="2346877" cy="400110"/>
          </a:xfrm>
          <a:prstGeom prst="rect">
            <a:avLst/>
          </a:prstGeom>
          <a:noFill/>
          <a:effectLst>
            <a:softEdge rad="635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de-CH" sz="2000" b="1" i="1" dirty="0"/>
              <a:t>In vitro </a:t>
            </a:r>
            <a:r>
              <a:rPr lang="de-CH" sz="2000" b="1" dirty="0" err="1"/>
              <a:t>digestibility</a:t>
            </a:r>
            <a:endParaRPr lang="de-CH" sz="2000" b="1" dirty="0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70AD4CA7-279C-40A7-B390-CD4384CC80B7}"/>
              </a:ext>
            </a:extLst>
          </p:cNvPr>
          <p:cNvSpPr txBox="1"/>
          <p:nvPr/>
        </p:nvSpPr>
        <p:spPr>
          <a:xfrm>
            <a:off x="9080936" y="151884"/>
            <a:ext cx="23229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2000" b="1" dirty="0" err="1"/>
              <a:t>Digestibility</a:t>
            </a:r>
            <a:r>
              <a:rPr lang="de-CH" sz="2000" b="1" dirty="0"/>
              <a:t> </a:t>
            </a:r>
            <a:r>
              <a:rPr lang="de-CH" sz="2000" b="1" dirty="0" err="1"/>
              <a:t>results</a:t>
            </a:r>
            <a:endParaRPr lang="de-CH" sz="2000" b="1" dirty="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52930FF5-A01C-4D05-922F-31C2C0F3C844}"/>
              </a:ext>
            </a:extLst>
          </p:cNvPr>
          <p:cNvSpPr txBox="1"/>
          <p:nvPr/>
        </p:nvSpPr>
        <p:spPr>
          <a:xfrm>
            <a:off x="3299954" y="103539"/>
            <a:ext cx="15585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2000" b="1" dirty="0"/>
              <a:t>Processing 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D82C1BFB-D492-48CE-8C55-A7FB96147F76}"/>
              </a:ext>
            </a:extLst>
          </p:cNvPr>
          <p:cNvSpPr txBox="1"/>
          <p:nvPr/>
        </p:nvSpPr>
        <p:spPr>
          <a:xfrm>
            <a:off x="645960" y="2135690"/>
            <a:ext cx="13543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 err="1"/>
              <a:t>Mealworm</a:t>
            </a:r>
            <a:endParaRPr lang="de-CH" sz="2000" b="1" dirty="0"/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90A65709-088E-449F-ADAC-1540D15FF7BE}"/>
              </a:ext>
            </a:extLst>
          </p:cNvPr>
          <p:cNvSpPr txBox="1"/>
          <p:nvPr/>
        </p:nvSpPr>
        <p:spPr>
          <a:xfrm>
            <a:off x="274652" y="6099300"/>
            <a:ext cx="18517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/>
              <a:t>Chicken </a:t>
            </a:r>
            <a:r>
              <a:rPr lang="de-CH" sz="2000" b="1" dirty="0" err="1"/>
              <a:t>meat</a:t>
            </a:r>
            <a:endParaRPr lang="de-CH" sz="2000" b="1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B5FBF16A-5587-480E-9FD8-951DA655C9DC}"/>
              </a:ext>
            </a:extLst>
          </p:cNvPr>
          <p:cNvSpPr txBox="1"/>
          <p:nvPr/>
        </p:nvSpPr>
        <p:spPr>
          <a:xfrm>
            <a:off x="706639" y="3981519"/>
            <a:ext cx="10534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b="1" dirty="0"/>
              <a:t>Cricket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23300D7F-6380-49B5-92B9-66C7040DD925}"/>
              </a:ext>
            </a:extLst>
          </p:cNvPr>
          <p:cNvSpPr txBox="1"/>
          <p:nvPr/>
        </p:nvSpPr>
        <p:spPr>
          <a:xfrm rot="16200000">
            <a:off x="-572695" y="2438396"/>
            <a:ext cx="17684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dirty="0" err="1"/>
              <a:t>Edible</a:t>
            </a:r>
            <a:r>
              <a:rPr lang="de-CH" sz="2000" dirty="0"/>
              <a:t> </a:t>
            </a:r>
            <a:r>
              <a:rPr lang="de-CH" sz="2000" dirty="0" err="1"/>
              <a:t>insects</a:t>
            </a:r>
            <a:endParaRPr lang="de-CH" sz="2000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8DEF368-2457-438F-9849-DF8FDD528524}"/>
              </a:ext>
            </a:extLst>
          </p:cNvPr>
          <p:cNvSpPr txBox="1"/>
          <p:nvPr/>
        </p:nvSpPr>
        <p:spPr>
          <a:xfrm rot="16200000">
            <a:off x="-491399" y="5199652"/>
            <a:ext cx="15808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2000" dirty="0"/>
              <a:t>Control </a:t>
            </a:r>
            <a:r>
              <a:rPr lang="de-CH" sz="2000" dirty="0" err="1"/>
              <a:t>food</a:t>
            </a:r>
            <a:endParaRPr lang="de-CH" sz="2000" dirty="0"/>
          </a:p>
        </p:txBody>
      </p: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8A22113E-B162-4151-87DE-7A550A571A05}"/>
              </a:ext>
            </a:extLst>
          </p:cNvPr>
          <p:cNvCxnSpPr/>
          <p:nvPr/>
        </p:nvCxnSpPr>
        <p:spPr bwMode="auto">
          <a:xfrm rot="19500000" flipV="1">
            <a:off x="2169491" y="5024693"/>
            <a:ext cx="1041365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C68FBC5E-F6E7-4DB1-A0F7-F8F3E2B3A6BB}"/>
              </a:ext>
            </a:extLst>
          </p:cNvPr>
          <p:cNvCxnSpPr/>
          <p:nvPr/>
        </p:nvCxnSpPr>
        <p:spPr bwMode="auto">
          <a:xfrm>
            <a:off x="2263655" y="3747705"/>
            <a:ext cx="853037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2" name="Textfeld 31">
            <a:extLst>
              <a:ext uri="{FF2B5EF4-FFF2-40B4-BE49-F238E27FC236}">
                <a16:creationId xmlns:a16="http://schemas.microsoft.com/office/drawing/2014/main" id="{9753D5CD-2EF0-4770-AE2E-2DD0048DE89C}"/>
              </a:ext>
            </a:extLst>
          </p:cNvPr>
          <p:cNvSpPr txBox="1"/>
          <p:nvPr/>
        </p:nvSpPr>
        <p:spPr>
          <a:xfrm>
            <a:off x="2970575" y="2369047"/>
            <a:ext cx="1962382" cy="1631216"/>
          </a:xfrm>
          <a:prstGeom prst="rect">
            <a:avLst/>
          </a:prstGeom>
          <a:solidFill>
            <a:schemeClr val="bg1"/>
          </a:solidFill>
          <a:effectLst>
            <a:softEdge rad="1524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de-CH" sz="2000" b="1" dirty="0" err="1"/>
              <a:t>blanched</a:t>
            </a:r>
            <a:endParaRPr lang="de-CH" sz="2000" b="1" dirty="0"/>
          </a:p>
          <a:p>
            <a:pPr algn="ctr"/>
            <a:r>
              <a:rPr lang="de-CH" sz="2000" b="1" dirty="0" err="1"/>
              <a:t>oven</a:t>
            </a:r>
            <a:r>
              <a:rPr lang="de-CH" sz="2000" b="1" dirty="0"/>
              <a:t>-/</a:t>
            </a:r>
            <a:r>
              <a:rPr lang="de-CH" sz="2000" b="1" dirty="0" err="1"/>
              <a:t>freeze-dried</a:t>
            </a:r>
            <a:endParaRPr lang="de-CH" sz="2000" b="1" dirty="0"/>
          </a:p>
          <a:p>
            <a:pPr algn="ctr"/>
            <a:r>
              <a:rPr lang="de-CH" sz="2000" b="1" dirty="0" err="1"/>
              <a:t>pulverized</a:t>
            </a:r>
            <a:r>
              <a:rPr lang="de-CH" sz="2000" b="1" dirty="0"/>
              <a:t> </a:t>
            </a:r>
          </a:p>
          <a:p>
            <a:pPr algn="ctr"/>
            <a:r>
              <a:rPr lang="de-CH" sz="2000" b="1" dirty="0" err="1"/>
              <a:t>chitin</a:t>
            </a:r>
            <a:r>
              <a:rPr lang="de-CH" sz="2000" b="1" dirty="0"/>
              <a:t> </a:t>
            </a:r>
            <a:r>
              <a:rPr lang="de-CH" sz="2000" b="1" dirty="0" err="1"/>
              <a:t>reduced</a:t>
            </a:r>
            <a:endParaRPr lang="de-CH" sz="2000" b="1" dirty="0"/>
          </a:p>
        </p:txBody>
      </p: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9C9B53CE-D076-405F-8B7F-89FDED4882F7}"/>
              </a:ext>
            </a:extLst>
          </p:cNvPr>
          <p:cNvCxnSpPr/>
          <p:nvPr/>
        </p:nvCxnSpPr>
        <p:spPr bwMode="auto">
          <a:xfrm rot="2100000">
            <a:off x="4832768" y="4351940"/>
            <a:ext cx="1041365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1D845804-C502-42BB-B3B1-11391DA7213D}"/>
              </a:ext>
            </a:extLst>
          </p:cNvPr>
          <p:cNvSpPr txBox="1"/>
          <p:nvPr/>
        </p:nvSpPr>
        <p:spPr>
          <a:xfrm>
            <a:off x="5481266" y="5853014"/>
            <a:ext cx="225949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de-CH" sz="1800" dirty="0" err="1"/>
              <a:t>workflow</a:t>
            </a:r>
            <a:r>
              <a:rPr lang="de-CH" sz="1800" dirty="0"/>
              <a:t> </a:t>
            </a:r>
            <a:r>
              <a:rPr lang="de-CH" sz="1800" dirty="0" err="1"/>
              <a:t>based</a:t>
            </a:r>
            <a:r>
              <a:rPr lang="de-CH" sz="1800" dirty="0"/>
              <a:t> on </a:t>
            </a:r>
          </a:p>
          <a:p>
            <a:pPr algn="ctr"/>
            <a:r>
              <a:rPr lang="de-CH" sz="1800" dirty="0"/>
              <a:t>INFOGEST </a:t>
            </a:r>
            <a:r>
              <a:rPr lang="de-CH" sz="1800" dirty="0" err="1"/>
              <a:t>protocol</a:t>
            </a:r>
            <a:endParaRPr lang="de-CH" sz="1800" dirty="0"/>
          </a:p>
          <a:p>
            <a:pPr algn="ctr"/>
            <a:r>
              <a:rPr lang="de-CH" sz="1800" dirty="0"/>
              <a:t>(Sousa et al. 2022)</a:t>
            </a: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7132FCAA-EE2F-4213-9C1D-E807750871E1}"/>
              </a:ext>
            </a:extLst>
          </p:cNvPr>
          <p:cNvGrpSpPr/>
          <p:nvPr/>
        </p:nvGrpSpPr>
        <p:grpSpPr>
          <a:xfrm>
            <a:off x="7528062" y="650498"/>
            <a:ext cx="977242" cy="2302571"/>
            <a:chOff x="7806633" y="1023468"/>
            <a:chExt cx="954472" cy="2248921"/>
          </a:xfrm>
        </p:grpSpPr>
        <p:grpSp>
          <p:nvGrpSpPr>
            <p:cNvPr id="10" name="Gruppieren 9">
              <a:extLst>
                <a:ext uri="{FF2B5EF4-FFF2-40B4-BE49-F238E27FC236}">
                  <a16:creationId xmlns:a16="http://schemas.microsoft.com/office/drawing/2014/main" id="{72EB2469-F73F-48CC-82D6-3098D10732C8}"/>
                </a:ext>
              </a:extLst>
            </p:cNvPr>
            <p:cNvGrpSpPr/>
            <p:nvPr/>
          </p:nvGrpSpPr>
          <p:grpSpPr>
            <a:xfrm>
              <a:off x="7806633" y="1146955"/>
              <a:ext cx="853037" cy="2125434"/>
              <a:chOff x="7806633" y="1146955"/>
              <a:chExt cx="853037" cy="2125434"/>
            </a:xfrm>
          </p:grpSpPr>
          <p:grpSp>
            <p:nvGrpSpPr>
              <p:cNvPr id="5" name="Gruppieren 4">
                <a:extLst>
                  <a:ext uri="{FF2B5EF4-FFF2-40B4-BE49-F238E27FC236}">
                    <a16:creationId xmlns:a16="http://schemas.microsoft.com/office/drawing/2014/main" id="{F7479675-CCA3-4391-B68A-55EFEB542203}"/>
                  </a:ext>
                </a:extLst>
              </p:cNvPr>
              <p:cNvGrpSpPr/>
              <p:nvPr/>
            </p:nvGrpSpPr>
            <p:grpSpPr>
              <a:xfrm>
                <a:off x="7806633" y="1146955"/>
                <a:ext cx="853037" cy="2125434"/>
                <a:chOff x="8913536" y="960971"/>
                <a:chExt cx="1981772" cy="4937798"/>
              </a:xfrm>
            </p:grpSpPr>
            <p:pic>
              <p:nvPicPr>
                <p:cNvPr id="104" name="Grafik 103" descr="Ein Bild, das Text enthält.&#10;&#10;Automatisch generierte Beschreibung">
                  <a:extLst>
                    <a:ext uri="{FF2B5EF4-FFF2-40B4-BE49-F238E27FC236}">
                      <a16:creationId xmlns:a16="http://schemas.microsoft.com/office/drawing/2014/main" id="{B49B63EE-30CA-8B10-6B39-EEA67121BD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222" t="85592" r="28333" b="9968"/>
                <a:stretch/>
              </p:blipFill>
              <p:spPr>
                <a:xfrm rot="16200000">
                  <a:off x="8166580" y="3168297"/>
                  <a:ext cx="4936053" cy="521403"/>
                </a:xfrm>
                <a:prstGeom prst="rect">
                  <a:avLst/>
                </a:prstGeom>
              </p:spPr>
            </p:pic>
            <p:pic>
              <p:nvPicPr>
                <p:cNvPr id="105" name="Grafik 104" descr="Ein Bild, das Text enthält.&#10;&#10;Automatisch generierte Beschreibung">
                  <a:extLst>
                    <a:ext uri="{FF2B5EF4-FFF2-40B4-BE49-F238E27FC236}">
                      <a16:creationId xmlns:a16="http://schemas.microsoft.com/office/drawing/2014/main" id="{9855250E-2DA5-4C29-96AC-E985CECB95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222" t="42113" r="28333" b="53532"/>
                <a:stretch/>
              </p:blipFill>
              <p:spPr>
                <a:xfrm rot="16200000">
                  <a:off x="7648392" y="3173276"/>
                  <a:ext cx="4936053" cy="511443"/>
                </a:xfrm>
                <a:prstGeom prst="rect">
                  <a:avLst/>
                </a:prstGeom>
              </p:spPr>
            </p:pic>
            <p:pic>
              <p:nvPicPr>
                <p:cNvPr id="106" name="Grafik 105" descr="Ein Bild, das Text enthält.&#10;&#10;Automatisch generierte Beschreibung">
                  <a:extLst>
                    <a:ext uri="{FF2B5EF4-FFF2-40B4-BE49-F238E27FC236}">
                      <a16:creationId xmlns:a16="http://schemas.microsoft.com/office/drawing/2014/main" id="{E32A9AC4-7EF1-4314-95D2-C354488876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222" t="5793" r="28333" b="86157"/>
                <a:stretch/>
              </p:blipFill>
              <p:spPr>
                <a:xfrm rot="16200000">
                  <a:off x="6918207" y="2958045"/>
                  <a:ext cx="4936053" cy="945396"/>
                </a:xfrm>
                <a:prstGeom prst="rect">
                  <a:avLst/>
                </a:prstGeom>
              </p:spPr>
            </p:pic>
          </p:grpSp>
          <p:sp>
            <p:nvSpPr>
              <p:cNvPr id="9" name="Rechteck 8">
                <a:extLst>
                  <a:ext uri="{FF2B5EF4-FFF2-40B4-BE49-F238E27FC236}">
                    <a16:creationId xmlns:a16="http://schemas.microsoft.com/office/drawing/2014/main" id="{B6A46A54-B36B-4DF5-961E-34ACC24195EB}"/>
                  </a:ext>
                </a:extLst>
              </p:cNvPr>
              <p:cNvSpPr/>
              <p:nvPr/>
            </p:nvSpPr>
            <p:spPr bwMode="auto">
              <a:xfrm>
                <a:off x="8043567" y="1166648"/>
                <a:ext cx="567559" cy="75675"/>
              </a:xfrm>
              <a:prstGeom prst="rect">
                <a:avLst/>
              </a:prstGeom>
              <a:solidFill>
                <a:schemeClr val="bg1"/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de-CH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</p:grp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AFD3DC27-0322-499B-ACCC-B8BFA1859BF2}"/>
                </a:ext>
              </a:extLst>
            </p:cNvPr>
            <p:cNvSpPr txBox="1"/>
            <p:nvPr/>
          </p:nvSpPr>
          <p:spPr>
            <a:xfrm>
              <a:off x="7919811" y="1023468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500" dirty="0" err="1"/>
                <a:t>Meal</a:t>
              </a:r>
              <a:r>
                <a:rPr lang="de-CH" sz="500" dirty="0"/>
                <a:t>-</a:t>
              </a:r>
            </a:p>
            <a:p>
              <a:r>
                <a:rPr lang="de-CH" sz="500" dirty="0" err="1"/>
                <a:t>worm</a:t>
              </a:r>
              <a:endParaRPr lang="de-CH" sz="500" dirty="0"/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391F1D67-DE63-4C5D-A3C3-60F1533F6034}"/>
                </a:ext>
              </a:extLst>
            </p:cNvPr>
            <p:cNvSpPr txBox="1"/>
            <p:nvPr/>
          </p:nvSpPr>
          <p:spPr>
            <a:xfrm>
              <a:off x="8131898" y="1061563"/>
              <a:ext cx="38343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500" dirty="0"/>
                <a:t>Cricket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9E59436C-56E3-45C9-BD30-52CE4E91B9F9}"/>
                </a:ext>
              </a:extLst>
            </p:cNvPr>
            <p:cNvSpPr txBox="1"/>
            <p:nvPr/>
          </p:nvSpPr>
          <p:spPr>
            <a:xfrm>
              <a:off x="8345607" y="1061563"/>
              <a:ext cx="4154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500" dirty="0"/>
                <a:t>Chicken</a:t>
              </a:r>
            </a:p>
          </p:txBody>
        </p:sp>
      </p:grpSp>
      <p:sp>
        <p:nvSpPr>
          <p:cNvPr id="48" name="Textfeld 47">
            <a:extLst>
              <a:ext uri="{FF2B5EF4-FFF2-40B4-BE49-F238E27FC236}">
                <a16:creationId xmlns:a16="http://schemas.microsoft.com/office/drawing/2014/main" id="{65F93D70-8143-4DB9-9F8D-B0E5C111DB9F}"/>
              </a:ext>
            </a:extLst>
          </p:cNvPr>
          <p:cNvSpPr txBox="1"/>
          <p:nvPr/>
        </p:nvSpPr>
        <p:spPr>
          <a:xfrm rot="16200000">
            <a:off x="11119540" y="5344064"/>
            <a:ext cx="1463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i="1" dirty="0"/>
              <a:t>In vitro </a:t>
            </a:r>
            <a:r>
              <a:rPr lang="de-CH" dirty="0"/>
              <a:t>DIAAS</a:t>
            </a:r>
          </a:p>
        </p:txBody>
      </p: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83046673-8F77-4146-AEB1-2510B6D9E2D9}"/>
              </a:ext>
            </a:extLst>
          </p:cNvPr>
          <p:cNvCxnSpPr/>
          <p:nvPr/>
        </p:nvCxnSpPr>
        <p:spPr bwMode="auto">
          <a:xfrm rot="19500000" flipV="1">
            <a:off x="7297308" y="4063324"/>
            <a:ext cx="1041365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59647291-58EB-41DC-B366-3BFCD7C06FEC}"/>
              </a:ext>
            </a:extLst>
          </p:cNvPr>
          <p:cNvCxnSpPr/>
          <p:nvPr/>
        </p:nvCxnSpPr>
        <p:spPr bwMode="auto">
          <a:xfrm>
            <a:off x="7404733" y="4924903"/>
            <a:ext cx="853037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0CC5125E-A785-4369-AB75-9ED12A31CEDE}"/>
              </a:ext>
            </a:extLst>
          </p:cNvPr>
          <p:cNvCxnSpPr/>
          <p:nvPr/>
        </p:nvCxnSpPr>
        <p:spPr bwMode="auto">
          <a:xfrm rot="19500000" flipV="1">
            <a:off x="4792242" y="3071746"/>
            <a:ext cx="1041365" cy="1"/>
          </a:xfrm>
          <a:prstGeom prst="straightConnector1">
            <a:avLst/>
          </a:prstGeom>
          <a:solidFill>
            <a:schemeClr val="accent1"/>
          </a:solidFill>
          <a:ln w="127000" cap="flat" cmpd="sng" algn="ctr">
            <a:solidFill>
              <a:schemeClr val="bg1">
                <a:lumMod val="65000"/>
              </a:schemeClr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5" name="Textfeld 44">
            <a:extLst>
              <a:ext uri="{FF2B5EF4-FFF2-40B4-BE49-F238E27FC236}">
                <a16:creationId xmlns:a16="http://schemas.microsoft.com/office/drawing/2014/main" id="{E8FCD657-AD19-4C81-B710-1AA63EF5A0D4}"/>
              </a:ext>
            </a:extLst>
          </p:cNvPr>
          <p:cNvSpPr txBox="1"/>
          <p:nvPr/>
        </p:nvSpPr>
        <p:spPr>
          <a:xfrm>
            <a:off x="6206677" y="103539"/>
            <a:ext cx="17604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2000" b="1" dirty="0"/>
              <a:t>Food </a:t>
            </a:r>
            <a:r>
              <a:rPr lang="de-CH" sz="2000" b="1" dirty="0" err="1"/>
              <a:t>analysis</a:t>
            </a:r>
            <a:r>
              <a:rPr lang="de-CH" sz="2000" b="1" dirty="0"/>
              <a:t> </a:t>
            </a:r>
          </a:p>
        </p:txBody>
      </p:sp>
      <p:pic>
        <p:nvPicPr>
          <p:cNvPr id="46" name="Grafik 45">
            <a:extLst>
              <a:ext uri="{FF2B5EF4-FFF2-40B4-BE49-F238E27FC236}">
                <a16:creationId xmlns:a16="http://schemas.microsoft.com/office/drawing/2014/main" id="{14B9F360-1EE4-4822-9DAE-6F892CE71E8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489538" y="815981"/>
            <a:ext cx="1597353" cy="1383928"/>
          </a:xfrm>
          <a:prstGeom prst="rect">
            <a:avLst/>
          </a:prstGeom>
        </p:spPr>
      </p:pic>
      <p:sp>
        <p:nvSpPr>
          <p:cNvPr id="49" name="Textfeld 48">
            <a:extLst>
              <a:ext uri="{FF2B5EF4-FFF2-40B4-BE49-F238E27FC236}">
                <a16:creationId xmlns:a16="http://schemas.microsoft.com/office/drawing/2014/main" id="{6DC61FA9-BD3B-492F-9D80-7540A2154152}"/>
              </a:ext>
            </a:extLst>
          </p:cNvPr>
          <p:cNvSpPr txBox="1"/>
          <p:nvPr/>
        </p:nvSpPr>
        <p:spPr>
          <a:xfrm>
            <a:off x="5584085" y="2246984"/>
            <a:ext cx="15973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 err="1"/>
              <a:t>Amino</a:t>
            </a:r>
            <a:r>
              <a:rPr lang="de-CH" dirty="0"/>
              <a:t> </a:t>
            </a:r>
            <a:r>
              <a:rPr lang="de-CH" dirty="0" err="1"/>
              <a:t>acids</a:t>
            </a:r>
            <a:endParaRPr lang="de-CH" dirty="0"/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62E6CC7-4CE4-4CAA-8E48-F60AA300DB13}"/>
              </a:ext>
            </a:extLst>
          </p:cNvPr>
          <p:cNvSpPr txBox="1"/>
          <p:nvPr/>
        </p:nvSpPr>
        <p:spPr>
          <a:xfrm>
            <a:off x="2961639" y="4404310"/>
            <a:ext cx="1962382" cy="400110"/>
          </a:xfrm>
          <a:prstGeom prst="rect">
            <a:avLst/>
          </a:prstGeom>
          <a:solidFill>
            <a:schemeClr val="bg1"/>
          </a:solidFill>
          <a:effectLst>
            <a:softEdge rad="1524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de-CH" sz="2000" b="1" dirty="0" err="1"/>
              <a:t>sous</a:t>
            </a:r>
            <a:r>
              <a:rPr lang="de-CH" sz="2000" b="1" dirty="0"/>
              <a:t>-vide 80°C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FAAFC0FC-E48C-4C13-94C9-27B65CA3936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1806" y="2591634"/>
            <a:ext cx="2880360" cy="2069592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9CD302DA-DEF2-4D9C-B1D7-14B6F6A7DA16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461" b="52053"/>
          <a:stretch/>
        </p:blipFill>
        <p:spPr>
          <a:xfrm>
            <a:off x="8791806" y="471226"/>
            <a:ext cx="2683796" cy="1995343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716FE6CF-A60D-44FC-9241-55AF27583B0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1372" y="4643636"/>
            <a:ext cx="2880360" cy="2069592"/>
          </a:xfrm>
          <a:prstGeom prst="rect">
            <a:avLst/>
          </a:prstGeom>
        </p:spPr>
      </p:pic>
      <p:sp>
        <p:nvSpPr>
          <p:cNvPr id="51" name="Textfeld 50">
            <a:extLst>
              <a:ext uri="{FF2B5EF4-FFF2-40B4-BE49-F238E27FC236}">
                <a16:creationId xmlns:a16="http://schemas.microsoft.com/office/drawing/2014/main" id="{BEA7C991-E5D4-45D4-924D-C9AD98277021}"/>
              </a:ext>
            </a:extLst>
          </p:cNvPr>
          <p:cNvSpPr txBox="1"/>
          <p:nvPr/>
        </p:nvSpPr>
        <p:spPr>
          <a:xfrm rot="16200000">
            <a:off x="10954783" y="1287692"/>
            <a:ext cx="17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Peptide </a:t>
            </a:r>
            <a:r>
              <a:rPr lang="de-CH" dirty="0" err="1"/>
              <a:t>patterns</a:t>
            </a:r>
            <a:r>
              <a:rPr lang="de-CH" dirty="0"/>
              <a:t> 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438B28DF-0D3A-4D63-A894-3CEAD2BF804F}"/>
              </a:ext>
            </a:extLst>
          </p:cNvPr>
          <p:cNvSpPr txBox="1"/>
          <p:nvPr/>
        </p:nvSpPr>
        <p:spPr>
          <a:xfrm rot="16200000">
            <a:off x="10763785" y="3331455"/>
            <a:ext cx="217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 Protein </a:t>
            </a:r>
            <a:r>
              <a:rPr lang="de-CH" dirty="0" err="1"/>
              <a:t>digestibility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715652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reitbild</PresentationFormat>
  <Paragraphs>2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ortmann Reto AGROSCOPE</dc:creator>
  <cp:lastModifiedBy>Egger Charlotte AGROSCOPE</cp:lastModifiedBy>
  <cp:revision>8</cp:revision>
  <dcterms:created xsi:type="dcterms:W3CDTF">2023-01-24T08:19:01Z</dcterms:created>
  <dcterms:modified xsi:type="dcterms:W3CDTF">2023-01-24T10:50:13Z</dcterms:modified>
</cp:coreProperties>
</file>